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61" r:id="rId3"/>
    <p:sldId id="262" r:id="rId4"/>
    <p:sldId id="263" r:id="rId5"/>
    <p:sldId id="266" r:id="rId6"/>
    <p:sldId id="264" r:id="rId7"/>
    <p:sldId id="265" r:id="rId8"/>
    <p:sldId id="271" r:id="rId9"/>
    <p:sldId id="272" r:id="rId10"/>
    <p:sldId id="267" r:id="rId11"/>
    <p:sldId id="257" r:id="rId12"/>
    <p:sldId id="258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75" d="100"/>
          <a:sy n="75" d="100"/>
        </p:scale>
        <p:origin x="-1152" y="19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D62179-AED9-43BE-B46B-771F2E5B5077}" type="datetimeFigureOut">
              <a:rPr lang="zh-CN" altLang="en-US" smtClean="0"/>
              <a:pPr/>
              <a:t>2017/1/20 Friday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F9BBF-DE29-43BC-824B-3CA97ECEE95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28464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2F9BBF-DE29-43BC-824B-3CA97ECEE951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687620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993676" y="4552265"/>
            <a:ext cx="7461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1.L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32 </a:t>
            </a:r>
            <a:endParaRPr lang="zh-CN" altLang="en-US" dirty="0"/>
          </a:p>
        </p:txBody>
      </p:sp>
      <p:pic>
        <p:nvPicPr>
          <p:cNvPr id="1027" name="Picture 3" descr="I:\肺隐球菌材料\2016-肺隐球菌病\2016-隐球菌肺病\病理报告及图片\病理号20152180徐慕松\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33900" y="833630"/>
            <a:ext cx="3769128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I:\肺隐球菌材料\胡志亮\Laboratoray confirmed cases\徐幕松-2014-08-25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62000" y="83363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H="1">
            <a:off x="3429000" y="2550503"/>
            <a:ext cx="76200" cy="4572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>
            <a:off x="6345382" y="1295400"/>
            <a:ext cx="30480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1143000" y="4940994"/>
            <a:ext cx="7010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CT </a:t>
            </a:r>
            <a:r>
              <a:rPr lang="en-US" altLang="zh-CN" dirty="0"/>
              <a:t>showed </a:t>
            </a:r>
            <a:r>
              <a:rPr lang="en-US" altLang="zh-CN" dirty="0" smtClean="0"/>
              <a:t>multiple </a:t>
            </a:r>
            <a:r>
              <a:rPr lang="en-US" altLang="zh-CN" dirty="0" err="1" smtClean="0"/>
              <a:t>cavitary</a:t>
            </a:r>
            <a:r>
              <a:rPr lang="en-US" altLang="zh-CN" dirty="0" smtClean="0"/>
              <a:t> nodules(A, black arrow revealed one of the nodules). Lung biopsy  </a:t>
            </a:r>
            <a:r>
              <a:rPr lang="en-US" altLang="zh-CN" dirty="0"/>
              <a:t>showed encapsulated yeast-like fungal cells </a:t>
            </a:r>
            <a:r>
              <a:rPr lang="en-US" altLang="zh-CN" dirty="0" smtClean="0"/>
              <a:t>(B, black arrow).</a:t>
            </a:r>
            <a:endParaRPr lang="en-US" altLang="zh-CN" dirty="0"/>
          </a:p>
        </p:txBody>
      </p:sp>
      <p:sp>
        <p:nvSpPr>
          <p:cNvPr id="2" name="TextBox 1"/>
          <p:cNvSpPr txBox="1"/>
          <p:nvPr/>
        </p:nvSpPr>
        <p:spPr>
          <a:xfrm>
            <a:off x="762000" y="833630"/>
            <a:ext cx="3810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33900" y="833630"/>
            <a:ext cx="3810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57214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371600" y="4267200"/>
            <a:ext cx="71608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10. Clinically probable 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</a:t>
            </a:r>
            <a:r>
              <a:rPr lang="en-US" altLang="zh-CN" b="1" dirty="0" smtClean="0"/>
              <a:t>57 </a:t>
            </a:r>
            <a:endParaRPr lang="zh-CN" altLang="en-US" dirty="0"/>
          </a:p>
        </p:txBody>
      </p:sp>
      <p:pic>
        <p:nvPicPr>
          <p:cNvPr id="9218" name="Picture 2" descr="I:\肺隐球菌材料\胡志亮\probable case of PC\邓卫明-2016-03-23.jpg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44079" y="963056"/>
            <a:ext cx="2880000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I:\肺隐球菌材料\胡志亮\probable case of PC\邓卫明-2016-06-20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23680" y="980728"/>
            <a:ext cx="2880000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1452464" y="4793704"/>
            <a:ext cx="662473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Chest CT showed </a:t>
            </a:r>
            <a:r>
              <a:rPr lang="en-US" altLang="zh-CN" dirty="0" smtClean="0"/>
              <a:t>multiple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s(A, black arrow showed one of the </a:t>
            </a:r>
            <a:r>
              <a:rPr lang="en-US" altLang="zh-CN" dirty="0" err="1" smtClean="0"/>
              <a:t>cavitary</a:t>
            </a:r>
            <a:r>
              <a:rPr lang="en-US" altLang="zh-CN" dirty="0" smtClean="0"/>
              <a:t> nodules) </a:t>
            </a:r>
            <a:r>
              <a:rPr lang="en-US" altLang="zh-CN" dirty="0"/>
              <a:t>with diffuse ground-glass opacities ( A, </a:t>
            </a:r>
            <a:r>
              <a:rPr lang="en-US" altLang="zh-CN" dirty="0" smtClean="0"/>
              <a:t>white arrows). </a:t>
            </a:r>
            <a:r>
              <a:rPr lang="en-US" altLang="zh-CN" dirty="0"/>
              <a:t>After anti-fungal therapy </a:t>
            </a:r>
            <a:r>
              <a:rPr lang="en-US" altLang="zh-CN" dirty="0" smtClean="0"/>
              <a:t>as well as treated for pneumocystis </a:t>
            </a:r>
            <a:r>
              <a:rPr lang="en-US" altLang="zh-CN" dirty="0"/>
              <a:t>pneumonia , chest CT showed resolution of the nodule (B, black arrow</a:t>
            </a:r>
            <a:r>
              <a:rPr lang="en-US" altLang="zh-CN" dirty="0" smtClean="0"/>
              <a:t>) and </a:t>
            </a:r>
            <a:r>
              <a:rPr lang="en-US" altLang="zh-CN" dirty="0"/>
              <a:t>diffuse ground-glass </a:t>
            </a:r>
            <a:r>
              <a:rPr lang="en-US" altLang="zh-CN" dirty="0" smtClean="0"/>
              <a:t>opacities.</a:t>
            </a:r>
            <a:endParaRPr lang="en-US" altLang="zh-CN" dirty="0"/>
          </a:p>
        </p:txBody>
      </p:sp>
      <p:sp>
        <p:nvSpPr>
          <p:cNvPr id="3" name="TextBox 2"/>
          <p:cNvSpPr txBox="1"/>
          <p:nvPr/>
        </p:nvSpPr>
        <p:spPr>
          <a:xfrm>
            <a:off x="1444079" y="963056"/>
            <a:ext cx="391617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23680" y="963056"/>
            <a:ext cx="391617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3381772" y="2060848"/>
            <a:ext cx="288032" cy="7200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2267744" y="2492896"/>
            <a:ext cx="0" cy="2880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3563888" y="2420728"/>
            <a:ext cx="0" cy="3602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6660232" y="2249252"/>
            <a:ext cx="288032" cy="7200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578885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F:\论文专著原始资料\临床研究\隐球菌病相关\2013-隐球菌肺炎\病人图片统计表格\王浩\王浩2010-10-08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48000" y="48600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>
            <a:off x="5099050" y="1879600"/>
            <a:ext cx="4953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5353050" y="2209800"/>
            <a:ext cx="76200" cy="5334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4343400" y="2349500"/>
            <a:ext cx="76200" cy="4953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824626" y="4622677"/>
            <a:ext cx="65488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</a:t>
            </a:r>
            <a:r>
              <a:rPr lang="en-US" altLang="zh-CN" dirty="0" smtClean="0"/>
              <a:t>showed solitary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(black arrow) with bilateral </a:t>
            </a:r>
            <a:r>
              <a:rPr lang="en-US" altLang="zh-CN" dirty="0"/>
              <a:t>pleural </a:t>
            </a:r>
            <a:r>
              <a:rPr lang="en-US" altLang="zh-CN" dirty="0" smtClean="0"/>
              <a:t>effusions(white arrows</a:t>
            </a:r>
            <a:r>
              <a:rPr lang="en-US" altLang="zh-CN" dirty="0"/>
              <a:t>). F</a:t>
            </a:r>
            <a:r>
              <a:rPr lang="en-US" altLang="zh-CN" dirty="0" smtClean="0"/>
              <a:t>ollow-up </a:t>
            </a:r>
            <a:r>
              <a:rPr lang="en-US" altLang="zh-CN" dirty="0"/>
              <a:t>chest CT </a:t>
            </a:r>
            <a:r>
              <a:rPr lang="en-US" altLang="zh-CN" dirty="0" smtClean="0"/>
              <a:t>scan </a:t>
            </a:r>
            <a:r>
              <a:rPr lang="en-US" altLang="zh-CN" dirty="0"/>
              <a:t>to define clinical </a:t>
            </a:r>
            <a:r>
              <a:rPr lang="en-US" altLang="zh-CN" dirty="0" smtClean="0"/>
              <a:t>response was </a:t>
            </a:r>
            <a:r>
              <a:rPr lang="en-US" altLang="zh-CN" dirty="0"/>
              <a:t>unavailable.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048000" y="4253345"/>
            <a:ext cx="4332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ase 11.Undefined case 1: patient No. 1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xmlns="" val="3248145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I:\肺隐球菌材料\胡志亮\un-defined\孔令成2014-07-0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766164" y="789710"/>
            <a:ext cx="3600000" cy="33652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889764" y="4253345"/>
            <a:ext cx="4202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Case 12. Undefined case 1: patient No. 38</a:t>
            </a:r>
            <a:endParaRPr lang="zh-CN" altLang="en-US" b="1" dirty="0"/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5410200" y="2209800"/>
            <a:ext cx="152400" cy="533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824626" y="4622677"/>
            <a:ext cx="65488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</a:t>
            </a:r>
            <a:r>
              <a:rPr lang="en-US" altLang="zh-CN" dirty="0" smtClean="0"/>
              <a:t>showed solitary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(black arrow). Follow-up </a:t>
            </a:r>
            <a:r>
              <a:rPr lang="en-US" altLang="zh-CN" dirty="0"/>
              <a:t>chest CT </a:t>
            </a:r>
            <a:r>
              <a:rPr lang="en-US" altLang="zh-CN" dirty="0" smtClean="0"/>
              <a:t>scan </a:t>
            </a:r>
            <a:r>
              <a:rPr lang="en-US" altLang="zh-CN" dirty="0"/>
              <a:t>to define clinical </a:t>
            </a:r>
            <a:r>
              <a:rPr lang="en-US" altLang="zh-CN" dirty="0" smtClean="0"/>
              <a:t>response was </a:t>
            </a:r>
            <a:r>
              <a:rPr lang="en-US" altLang="zh-CN" dirty="0"/>
              <a:t>unavailable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xmlns="" val="322304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I:\肺隐球菌材料\胡志亮\Laboratoray confirmed cases\谭维伟-2014-10-9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908556" y="711115"/>
            <a:ext cx="3600000" cy="35952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>
            <a:off x="3505200" y="1524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1103160" y="4387334"/>
            <a:ext cx="72454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2. L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44</a:t>
            </a:r>
            <a:endParaRPr lang="zh-CN" altLang="en-US" dirty="0"/>
          </a:p>
        </p:txBody>
      </p:sp>
      <p:sp>
        <p:nvSpPr>
          <p:cNvPr id="7" name="Rectangle 6"/>
          <p:cNvSpPr/>
          <p:nvPr/>
        </p:nvSpPr>
        <p:spPr>
          <a:xfrm>
            <a:off x="1219200" y="4941332"/>
            <a:ext cx="7010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Chest CT showed </a:t>
            </a:r>
            <a:r>
              <a:rPr lang="en-US" altLang="zh-CN" dirty="0" smtClean="0"/>
              <a:t>solitary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(A</a:t>
            </a:r>
            <a:r>
              <a:rPr lang="en-US" altLang="zh-CN" dirty="0"/>
              <a:t>, black </a:t>
            </a:r>
            <a:r>
              <a:rPr lang="en-US" altLang="zh-CN" dirty="0" smtClean="0"/>
              <a:t>arrow). </a:t>
            </a:r>
            <a:r>
              <a:rPr lang="en-US" altLang="zh-CN" dirty="0"/>
              <a:t>Lung biopsy  showed encapsulated yeast-like fungal cells (B, </a:t>
            </a:r>
            <a:r>
              <a:rPr lang="en-US" altLang="zh-CN" dirty="0" smtClean="0"/>
              <a:t>black </a:t>
            </a:r>
            <a:r>
              <a:rPr lang="en-US" altLang="zh-CN" dirty="0"/>
              <a:t>arrow</a:t>
            </a:r>
            <a:r>
              <a:rPr lang="en-US" altLang="zh-CN" dirty="0" smtClean="0"/>
              <a:t>).</a:t>
            </a:r>
            <a:endParaRPr lang="en-US" altLang="zh-CN" dirty="0"/>
          </a:p>
        </p:txBody>
      </p:sp>
      <p:pic>
        <p:nvPicPr>
          <p:cNvPr id="3074" name="Picture 2" descr="I:\肺隐球菌材料\2016-肺隐球菌病\2016-隐球菌肺病\病理报告及图片\病理号20143077谭维伟\1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24400" y="708749"/>
            <a:ext cx="3769811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10921" y="708749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24400" y="708749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6794222" y="1879023"/>
            <a:ext cx="0" cy="43988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543665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I:\肺隐球菌材料\胡志亮\Laboratoray confirmed cases\吴长斌 2014-06-19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62000" y="838200"/>
            <a:ext cx="3600000" cy="35952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143000" y="4572000"/>
            <a:ext cx="717341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3.L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37 </a:t>
            </a:r>
            <a:endParaRPr lang="zh-CN" altLang="en-US" dirty="0"/>
          </a:p>
        </p:txBody>
      </p:sp>
      <p:pic>
        <p:nvPicPr>
          <p:cNvPr id="4099" name="Picture 3" descr="I:\肺隐球菌材料\2016-肺隐球菌病\2016-隐球菌肺病\病理报告及图片\病理号20141833吴长斌\2015-08-05-11-21-00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492336" y="852577"/>
            <a:ext cx="3633803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6" name="Straight Arrow Connector 5"/>
          <p:cNvCxnSpPr/>
          <p:nvPr/>
        </p:nvCxnSpPr>
        <p:spPr>
          <a:xfrm flipH="1">
            <a:off x="6261570" y="2510994"/>
            <a:ext cx="604935" cy="2831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3048000" y="2438400"/>
            <a:ext cx="152400" cy="2831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1219200" y="4941332"/>
            <a:ext cx="7010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solitary nodule(A</a:t>
            </a:r>
            <a:r>
              <a:rPr lang="en-US" altLang="zh-CN" dirty="0"/>
              <a:t>, black </a:t>
            </a:r>
            <a:r>
              <a:rPr lang="en-US" altLang="zh-CN" dirty="0" smtClean="0"/>
              <a:t>arrow). </a:t>
            </a:r>
            <a:r>
              <a:rPr lang="en-US" altLang="zh-CN" dirty="0"/>
              <a:t>Lung biopsy  showed </a:t>
            </a:r>
            <a:r>
              <a:rPr lang="en-US" altLang="zh-CN" dirty="0" smtClean="0"/>
              <a:t>yeast-like </a:t>
            </a:r>
            <a:r>
              <a:rPr lang="en-US" altLang="zh-CN" dirty="0"/>
              <a:t>fungal cells (B, </a:t>
            </a:r>
            <a:r>
              <a:rPr lang="en-US" altLang="zh-CN" dirty="0" smtClean="0"/>
              <a:t>black arrow).</a:t>
            </a:r>
            <a:endParaRPr lang="en-US" altLang="zh-CN" dirty="0"/>
          </a:p>
          <a:p>
            <a:endParaRPr lang="en-US" altLang="zh-CN" dirty="0"/>
          </a:p>
        </p:txBody>
      </p:sp>
      <p:sp>
        <p:nvSpPr>
          <p:cNvPr id="9" name="TextBox 8"/>
          <p:cNvSpPr txBox="1"/>
          <p:nvPr/>
        </p:nvSpPr>
        <p:spPr>
          <a:xfrm>
            <a:off x="758521" y="838200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05325" y="838200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032199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35012" y="4037418"/>
            <a:ext cx="730939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4. L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</a:t>
            </a:r>
            <a:r>
              <a:rPr lang="en-US" altLang="zh-CN" b="1" dirty="0" smtClean="0"/>
              <a:t>52</a:t>
            </a:r>
            <a:endParaRPr lang="zh-CN" altLang="en-US" dirty="0"/>
          </a:p>
        </p:txBody>
      </p:sp>
      <p:pic>
        <p:nvPicPr>
          <p:cNvPr id="5122" name="Picture 2" descr="I:\肺隐球菌材料\2016-肺隐球菌病\2016-隐球菌肺病\病理报告及图片\病理号20151725董玉才\1.jpg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59632" y="836712"/>
            <a:ext cx="2880000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I:\肺隐球菌材料\胡志亮\Laboratoray confirmed cases\董育才 2015-09-21-2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324350" y="836712"/>
            <a:ext cx="2880000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1028700" y="4406750"/>
            <a:ext cx="70104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At admission, Chest </a:t>
            </a:r>
            <a:r>
              <a:rPr lang="en-US" altLang="zh-CN" dirty="0"/>
              <a:t>CT showed </a:t>
            </a:r>
            <a:r>
              <a:rPr lang="en-US" altLang="zh-CN" dirty="0" smtClean="0"/>
              <a:t>multiple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s(the original CT images were not available due to technical problems).</a:t>
            </a:r>
            <a:r>
              <a:rPr lang="en-US" altLang="zh-CN" dirty="0"/>
              <a:t> Lung biopsy  showed </a:t>
            </a:r>
            <a:r>
              <a:rPr lang="en-US" altLang="zh-CN" dirty="0" smtClean="0"/>
              <a:t>yeast-like </a:t>
            </a:r>
            <a:r>
              <a:rPr lang="en-US" altLang="zh-CN" dirty="0"/>
              <a:t>fungal cells </a:t>
            </a:r>
            <a:r>
              <a:rPr lang="en-US" altLang="zh-CN" dirty="0" smtClean="0"/>
              <a:t>(A, black arrow). After treated for about 3 months, the patient’s condition improved. Chest CT showed resolution of the nodules that the nodules became solid and smaller(B, black arrow showed one of these nodules).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6372200" y="2161431"/>
            <a:ext cx="72008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3270920" y="1814364"/>
            <a:ext cx="72008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259632" y="836712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24350" y="836712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868611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43000" y="4572000"/>
            <a:ext cx="7086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5. </a:t>
            </a:r>
            <a:r>
              <a:rPr lang="en-US" altLang="zh-CN" b="1" dirty="0"/>
              <a:t>L</a:t>
            </a:r>
            <a:r>
              <a:rPr lang="en-US" altLang="zh-CN" b="1" dirty="0" smtClean="0"/>
              <a:t>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</a:t>
            </a:r>
            <a:r>
              <a:rPr lang="en-US" altLang="zh-CN" b="1" dirty="0" smtClean="0"/>
              <a:t>49</a:t>
            </a:r>
            <a:endParaRPr lang="zh-CN" altLang="en-US" dirty="0"/>
          </a:p>
        </p:txBody>
      </p:sp>
      <p:pic>
        <p:nvPicPr>
          <p:cNvPr id="2050" name="Picture 2" descr="I:\肺隐球菌材料\胡志亮\Laboratoray confirmed cases\朱云春 2015-09-24-2.jp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59424" y="620688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I:\肺隐球菌材料\胡志亮\Laboratoray confirmed cases\朱云春 2015-03-23-1.jpg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83568" y="623392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19200" y="4941332"/>
            <a:ext cx="7010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solitary nodule(A</a:t>
            </a:r>
            <a:r>
              <a:rPr lang="en-US" altLang="zh-CN" dirty="0"/>
              <a:t>, black </a:t>
            </a:r>
            <a:r>
              <a:rPr lang="en-US" altLang="zh-CN" dirty="0" smtClean="0"/>
              <a:t>arrow</a:t>
            </a:r>
            <a:r>
              <a:rPr lang="en-US" altLang="zh-CN" dirty="0"/>
              <a:t>). </a:t>
            </a:r>
            <a:r>
              <a:rPr lang="en-US" altLang="zh-CN" dirty="0" smtClean="0"/>
              <a:t>Sputum </a:t>
            </a:r>
            <a:r>
              <a:rPr lang="en-US" altLang="zh-CN" dirty="0"/>
              <a:t>culture </a:t>
            </a:r>
            <a:r>
              <a:rPr lang="en-US" altLang="zh-CN" dirty="0" smtClean="0"/>
              <a:t>grew </a:t>
            </a:r>
            <a:r>
              <a:rPr lang="en-US" altLang="zh-CN" dirty="0" err="1"/>
              <a:t>cryptococcal</a:t>
            </a:r>
            <a:r>
              <a:rPr lang="en-US" altLang="zh-CN" dirty="0"/>
              <a:t> </a:t>
            </a:r>
            <a:r>
              <a:rPr lang="en-US" altLang="zh-CN" dirty="0" err="1" smtClean="0"/>
              <a:t>spp</a:t>
            </a:r>
            <a:r>
              <a:rPr lang="en-US" altLang="zh-CN" dirty="0" smtClean="0"/>
              <a:t>..After anti-fungal therapy, chest CT showed resolution of the nodule(B, </a:t>
            </a:r>
            <a:r>
              <a:rPr lang="en-US" altLang="zh-CN" dirty="0"/>
              <a:t>black arrow</a:t>
            </a:r>
            <a:r>
              <a:rPr lang="en-US" altLang="zh-CN" dirty="0" smtClean="0"/>
              <a:t>).</a:t>
            </a:r>
            <a:endParaRPr lang="en-US" altLang="zh-CN" dirty="0"/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2051720" y="2384884"/>
            <a:ext cx="108012" cy="18002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>
            <a:off x="6156176" y="2384884"/>
            <a:ext cx="144016" cy="18002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83568" y="652046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59424" y="623392"/>
            <a:ext cx="384479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14366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I:\肺隐球菌材料\胡志亮\Laboratoray confirmed cases\马延良-2016-01-16-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697390" y="3010746"/>
            <a:ext cx="2504842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I:\肺隐球菌材料\胡志亮\Laboratoray confirmed cases\马延良-2015-11-16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52400" y="76200"/>
            <a:ext cx="2504842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I:\肺隐球菌材料\胡志亮\Laboratoray confirmed cases\马延良-2015-11-16-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725099" y="76200"/>
            <a:ext cx="2504842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I:\肺隐球菌材料\胡志亮\Laboratoray confirmed cases\马延良-2016-01-16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52400" y="3010746"/>
            <a:ext cx="2504842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5202233" y="90055"/>
            <a:ext cx="378936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6. Laboratory-confirmed </a:t>
            </a:r>
            <a:r>
              <a:rPr lang="en-US" altLang="zh-CN" b="1" dirty="0"/>
              <a:t>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</a:t>
            </a:r>
            <a:r>
              <a:rPr lang="en-US" altLang="zh-CN" b="1" dirty="0" smtClean="0"/>
              <a:t>55</a:t>
            </a:r>
            <a:endParaRPr lang="zh-CN" altLang="en-US" dirty="0"/>
          </a:p>
        </p:txBody>
      </p:sp>
      <p:sp>
        <p:nvSpPr>
          <p:cNvPr id="7" name="Rectangle 6"/>
          <p:cNvSpPr/>
          <p:nvPr/>
        </p:nvSpPr>
        <p:spPr>
          <a:xfrm>
            <a:off x="5332721" y="1302092"/>
            <a:ext cx="352839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solitary </a:t>
            </a:r>
            <a:r>
              <a:rPr lang="en-US" altLang="zh-CN" dirty="0"/>
              <a:t>nodule with multi-focal pneumonia (A, black </a:t>
            </a:r>
            <a:r>
              <a:rPr lang="en-US" altLang="zh-CN" dirty="0" smtClean="0"/>
              <a:t>arrow; B, black arrows). Sputum </a:t>
            </a:r>
            <a:r>
              <a:rPr lang="en-US" altLang="zh-CN" dirty="0"/>
              <a:t>culture </a:t>
            </a:r>
            <a:r>
              <a:rPr lang="en-US" altLang="zh-CN" dirty="0" smtClean="0"/>
              <a:t>grew </a:t>
            </a:r>
            <a:r>
              <a:rPr lang="en-US" altLang="zh-CN" dirty="0" err="1"/>
              <a:t>cryptococcal</a:t>
            </a:r>
            <a:r>
              <a:rPr lang="en-US" altLang="zh-CN" dirty="0"/>
              <a:t> </a:t>
            </a:r>
            <a:r>
              <a:rPr lang="en-US" altLang="zh-CN" dirty="0" err="1" smtClean="0"/>
              <a:t>spp</a:t>
            </a:r>
            <a:r>
              <a:rPr lang="en-US" altLang="zh-CN" dirty="0" smtClean="0"/>
              <a:t>..After anti-fungal therapy, chest CT showed resolution of the nodule and pneumonia(C, </a:t>
            </a:r>
            <a:r>
              <a:rPr lang="en-US" altLang="zh-CN" dirty="0"/>
              <a:t>black </a:t>
            </a:r>
            <a:r>
              <a:rPr lang="en-US" altLang="zh-CN" dirty="0" smtClean="0"/>
              <a:t>arrow; D).</a:t>
            </a:r>
            <a:endParaRPr lang="en-US" altLang="zh-CN" dirty="0"/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1043608" y="1124744"/>
            <a:ext cx="0" cy="3914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52400" y="90055"/>
            <a:ext cx="38715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725099" y="76200"/>
            <a:ext cx="38715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3491880" y="1124744"/>
            <a:ext cx="0" cy="3914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H="1">
            <a:off x="4389884" y="1117418"/>
            <a:ext cx="288032" cy="10944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827584" y="4149080"/>
            <a:ext cx="216024" cy="3016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52400" y="2995471"/>
            <a:ext cx="38715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C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83923" y="3010746"/>
            <a:ext cx="38715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</a:rPr>
              <a:t>D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19293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 descr="I:\肺隐球菌材料\胡志亮\Clincial confirmed case of PC\陈仁合2014-12-09.jpg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56018" y="53340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I:\肺隐球菌材料\胡志亮\Clincial confirmed case of PC\陈仁合2014-11-06.jpg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38200" y="53340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1371600" y="4267200"/>
            <a:ext cx="708441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7. Clinically confirmed 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46</a:t>
            </a:r>
            <a:endParaRPr lang="zh-CN" alt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3574475" y="1839191"/>
            <a:ext cx="0" cy="2286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3671455" y="1905000"/>
            <a:ext cx="0" cy="2286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7446820" y="2001982"/>
            <a:ext cx="0" cy="2286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7557655" y="2067791"/>
            <a:ext cx="0" cy="2286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2057400" y="2182091"/>
            <a:ext cx="0" cy="408709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429000" y="2333400"/>
            <a:ext cx="0" cy="4098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1393278" y="4636532"/>
            <a:ext cx="677912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multiple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s( </a:t>
            </a:r>
            <a:r>
              <a:rPr lang="en-US" altLang="zh-CN" dirty="0"/>
              <a:t>A, black </a:t>
            </a:r>
            <a:r>
              <a:rPr lang="en-US" altLang="zh-CN" dirty="0" smtClean="0"/>
              <a:t>arrows) </a:t>
            </a:r>
            <a:r>
              <a:rPr lang="en-US" altLang="zh-CN" dirty="0"/>
              <a:t>with bilateral pleural effusions </a:t>
            </a:r>
            <a:r>
              <a:rPr lang="en-US" altLang="zh-CN" dirty="0" smtClean="0"/>
              <a:t>(A, white arrows). After anti-fungal therapy, chest CT showed resolution of the nodules (B, black arrows) and</a:t>
            </a:r>
            <a:r>
              <a:rPr lang="en-US" altLang="zh-CN" dirty="0"/>
              <a:t> bilateral pleural effusions </a:t>
            </a:r>
            <a:r>
              <a:rPr lang="en-US" altLang="zh-CN" dirty="0" smtClean="0"/>
              <a:t>(B).</a:t>
            </a:r>
            <a:endParaRPr lang="en-US" altLang="zh-CN" dirty="0"/>
          </a:p>
        </p:txBody>
      </p:sp>
      <p:sp>
        <p:nvSpPr>
          <p:cNvPr id="2" name="TextBox 1"/>
          <p:cNvSpPr txBox="1"/>
          <p:nvPr/>
        </p:nvSpPr>
        <p:spPr>
          <a:xfrm>
            <a:off x="838200" y="533400"/>
            <a:ext cx="42143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56018" y="542925"/>
            <a:ext cx="42143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7322132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I:\肺隐球菌材料\胡志亮\Clincial confirmed case of PC\钱明清2013-06-2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27584" y="86460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I:\肺隐球菌材料\胡志亮\Clincial confirmed case of PC\钱明清2013-11-1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49924" y="864600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1371600" y="4797152"/>
            <a:ext cx="73048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8. Clinically confirmed 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23</a:t>
            </a:r>
            <a:endParaRPr lang="zh-CN" altLang="en-US" dirty="0"/>
          </a:p>
        </p:txBody>
      </p:sp>
      <p:sp>
        <p:nvSpPr>
          <p:cNvPr id="5" name="Rectangle 4"/>
          <p:cNvSpPr/>
          <p:nvPr/>
        </p:nvSpPr>
        <p:spPr>
          <a:xfrm>
            <a:off x="1371600" y="5166484"/>
            <a:ext cx="677912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solitary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( </a:t>
            </a:r>
            <a:r>
              <a:rPr lang="en-US" altLang="zh-CN" dirty="0"/>
              <a:t>A, black </a:t>
            </a:r>
            <a:r>
              <a:rPr lang="en-US" altLang="zh-CN" dirty="0" smtClean="0"/>
              <a:t>arrow). After anti-fungal therapy, chest CT showed resolution of the nodule (B, black arrow).</a:t>
            </a:r>
            <a:endParaRPr lang="en-US" altLang="zh-CN" dirty="0"/>
          </a:p>
        </p:txBody>
      </p:sp>
      <p:sp>
        <p:nvSpPr>
          <p:cNvPr id="2" name="TextBox 1"/>
          <p:cNvSpPr txBox="1"/>
          <p:nvPr/>
        </p:nvSpPr>
        <p:spPr>
          <a:xfrm>
            <a:off x="827584" y="864600"/>
            <a:ext cx="432048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971306" y="881475"/>
            <a:ext cx="432048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3131840" y="3284984"/>
            <a:ext cx="43204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>
            <a:off x="7236296" y="2996952"/>
            <a:ext cx="43204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4210056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I:\肺隐球菌材料\胡志亮\probable case of PC\肖海东2013-04-26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99592" y="620688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I:\肺隐球菌材料\胡志亮\probable case of PC\肖海东2013-07-09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32040" y="620688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371600" y="4267200"/>
            <a:ext cx="6705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Case 9. Clinically probable pulmonary </a:t>
            </a:r>
            <a:r>
              <a:rPr lang="en-US" altLang="zh-CN" b="1" dirty="0" err="1" smtClean="0"/>
              <a:t>cryptococcosis</a:t>
            </a:r>
            <a:r>
              <a:rPr lang="en-US" altLang="zh-CN" b="1" dirty="0" smtClean="0"/>
              <a:t> : patient No. 20</a:t>
            </a:r>
            <a:endParaRPr lang="zh-CN" altLang="en-US" dirty="0"/>
          </a:p>
        </p:txBody>
      </p:sp>
      <p:sp>
        <p:nvSpPr>
          <p:cNvPr id="6" name="Rectangle 5"/>
          <p:cNvSpPr/>
          <p:nvPr/>
        </p:nvSpPr>
        <p:spPr>
          <a:xfrm>
            <a:off x="1371600" y="4797152"/>
            <a:ext cx="677912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Chest </a:t>
            </a:r>
            <a:r>
              <a:rPr lang="en-US" altLang="zh-CN" dirty="0"/>
              <a:t>CT showed </a:t>
            </a:r>
            <a:r>
              <a:rPr lang="en-US" altLang="zh-CN" dirty="0" smtClean="0"/>
              <a:t>solitary </a:t>
            </a:r>
            <a:r>
              <a:rPr lang="en-US" altLang="zh-CN" dirty="0" err="1"/>
              <a:t>cavitary</a:t>
            </a:r>
            <a:r>
              <a:rPr lang="en-US" altLang="zh-CN" dirty="0"/>
              <a:t> </a:t>
            </a:r>
            <a:r>
              <a:rPr lang="en-US" altLang="zh-CN" dirty="0" smtClean="0"/>
              <a:t>nodule( </a:t>
            </a:r>
            <a:r>
              <a:rPr lang="en-US" altLang="zh-CN" dirty="0"/>
              <a:t>A, black </a:t>
            </a:r>
            <a:r>
              <a:rPr lang="en-US" altLang="zh-CN" dirty="0" smtClean="0"/>
              <a:t>arrow</a:t>
            </a:r>
            <a:r>
              <a:rPr lang="en-US" altLang="zh-CN" dirty="0"/>
              <a:t>) with </a:t>
            </a:r>
            <a:r>
              <a:rPr lang="en-US" altLang="zh-CN" dirty="0" smtClean="0"/>
              <a:t>multi-focal pneumonia(A, white arrows). After anti-fungal and anti-bacterial therapies, chest CT showed resolution of the nodule (B, black arrow) and pneumonia.</a:t>
            </a:r>
            <a:endParaRPr lang="en-US" altLang="zh-CN" dirty="0"/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3491880" y="1926357"/>
            <a:ext cx="144016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1691680" y="2214389"/>
            <a:ext cx="288032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3491880" y="2636912"/>
            <a:ext cx="72008" cy="2880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7524328" y="2070373"/>
            <a:ext cx="144016" cy="27850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899592" y="620688"/>
            <a:ext cx="472008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A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32040" y="644476"/>
            <a:ext cx="472008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</a:rPr>
              <a:t>B</a:t>
            </a:r>
            <a:endParaRPr lang="zh-CN" alt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34027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581</Words>
  <Application>Microsoft Office PowerPoint</Application>
  <PresentationFormat>全屏显示(4:3)</PresentationFormat>
  <Paragraphs>47</Paragraphs>
  <Slides>12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3" baseType="lpstr">
      <vt:lpstr>Office Theme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utoBVT</cp:lastModifiedBy>
  <cp:revision>50</cp:revision>
  <dcterms:created xsi:type="dcterms:W3CDTF">2006-08-16T00:00:00Z</dcterms:created>
  <dcterms:modified xsi:type="dcterms:W3CDTF">2017-01-20T09:58:25Z</dcterms:modified>
</cp:coreProperties>
</file>